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7"/>
  </p:notesMasterIdLst>
  <p:sldIdLst>
    <p:sldId id="256" r:id="rId5"/>
    <p:sldId id="25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322" y="-2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48797A-A5F5-4108-A3D8-01E0ED8DA9AE}" type="datetimeFigureOut">
              <a:rPr lang="en-GB" smtClean="0"/>
              <a:t>04/01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260B09-F559-42F6-9E9B-8B4CD7DA6A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33563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B46FEC-DB87-4660-9779-BF875573A9BA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36431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89F3-4D40-463D-93DC-9EBFACC6F082}" type="datetimeFigureOut">
              <a:rPr lang="en-GB" smtClean="0"/>
              <a:t>0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614BD-70A8-473D-9FE2-B266E8787D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77364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89F3-4D40-463D-93DC-9EBFACC6F082}" type="datetimeFigureOut">
              <a:rPr lang="en-GB" smtClean="0"/>
              <a:t>0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614BD-70A8-473D-9FE2-B266E8787D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9662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89F3-4D40-463D-93DC-9EBFACC6F082}" type="datetimeFigureOut">
              <a:rPr lang="en-GB" smtClean="0"/>
              <a:t>0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614BD-70A8-473D-9FE2-B266E8787D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4847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89F3-4D40-463D-93DC-9EBFACC6F082}" type="datetimeFigureOut">
              <a:rPr lang="en-GB" smtClean="0"/>
              <a:t>0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614BD-70A8-473D-9FE2-B266E8787D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4592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89F3-4D40-463D-93DC-9EBFACC6F082}" type="datetimeFigureOut">
              <a:rPr lang="en-GB" smtClean="0"/>
              <a:t>0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614BD-70A8-473D-9FE2-B266E8787D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644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89F3-4D40-463D-93DC-9EBFACC6F082}" type="datetimeFigureOut">
              <a:rPr lang="en-GB" smtClean="0"/>
              <a:t>04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614BD-70A8-473D-9FE2-B266E8787D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8112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89F3-4D40-463D-93DC-9EBFACC6F082}" type="datetimeFigureOut">
              <a:rPr lang="en-GB" smtClean="0"/>
              <a:t>04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614BD-70A8-473D-9FE2-B266E8787D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11300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89F3-4D40-463D-93DC-9EBFACC6F082}" type="datetimeFigureOut">
              <a:rPr lang="en-GB" smtClean="0"/>
              <a:t>04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614BD-70A8-473D-9FE2-B266E8787D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966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89F3-4D40-463D-93DC-9EBFACC6F082}" type="datetimeFigureOut">
              <a:rPr lang="en-GB" smtClean="0"/>
              <a:t>04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614BD-70A8-473D-9FE2-B266E8787D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2177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89F3-4D40-463D-93DC-9EBFACC6F082}" type="datetimeFigureOut">
              <a:rPr lang="en-GB" smtClean="0"/>
              <a:t>04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614BD-70A8-473D-9FE2-B266E8787D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0160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2D89F3-4D40-463D-93DC-9EBFACC6F082}" type="datetimeFigureOut">
              <a:rPr lang="en-GB" smtClean="0"/>
              <a:t>04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614BD-70A8-473D-9FE2-B266E8787D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46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2D89F3-4D40-463D-93DC-9EBFACC6F082}" type="datetimeFigureOut">
              <a:rPr lang="en-GB" smtClean="0"/>
              <a:t>0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614BD-70A8-473D-9FE2-B266E8787D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30784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/>
          <a:srcRect b="49904"/>
          <a:stretch/>
        </p:blipFill>
        <p:spPr>
          <a:xfrm>
            <a:off x="1828801" y="11431"/>
            <a:ext cx="6477000" cy="227457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09834" y="2895600"/>
            <a:ext cx="2131271" cy="2131271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 flipH="1">
            <a:off x="6705601" y="4502064"/>
            <a:ext cx="733425" cy="52480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57188" y="4755768"/>
            <a:ext cx="2012755" cy="2012755"/>
          </a:xfrm>
          <a:prstGeom prst="rect">
            <a:avLst/>
          </a:prstGeom>
        </p:spPr>
      </p:pic>
      <p:cxnSp>
        <p:nvCxnSpPr>
          <p:cNvPr id="11" name="Straight Arrow Connector 10"/>
          <p:cNvCxnSpPr/>
          <p:nvPr/>
        </p:nvCxnSpPr>
        <p:spPr>
          <a:xfrm flipV="1">
            <a:off x="3439184" y="1447800"/>
            <a:ext cx="904216" cy="1524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flipV="1">
            <a:off x="5663565" y="1447800"/>
            <a:ext cx="852852" cy="1524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 flipH="1">
            <a:off x="6159402" y="1452827"/>
            <a:ext cx="762000" cy="83317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3"/>
          <a:srcRect t="50347" r="63099"/>
          <a:stretch/>
        </p:blipFill>
        <p:spPr>
          <a:xfrm>
            <a:off x="3929392" y="2345696"/>
            <a:ext cx="2390116" cy="2254475"/>
          </a:xfrm>
          <a:prstGeom prst="rect">
            <a:avLst/>
          </a:prstGeom>
        </p:spPr>
      </p:pic>
      <p:cxnSp>
        <p:nvCxnSpPr>
          <p:cNvPr id="23" name="Straight Arrow Connector 22"/>
          <p:cNvCxnSpPr/>
          <p:nvPr/>
        </p:nvCxnSpPr>
        <p:spPr>
          <a:xfrm>
            <a:off x="5648862" y="3292579"/>
            <a:ext cx="1021080" cy="20290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122458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 algn="just">
              <a:buNone/>
            </a:pPr>
            <a:r>
              <a:rPr lang="en-GB" b="1" dirty="0"/>
              <a:t>Figure S1: </a:t>
            </a:r>
            <a:r>
              <a:rPr lang="en-US" b="1" dirty="0"/>
              <a:t>Gating strategy for exhausted CD21- B cells in a </a:t>
            </a:r>
            <a:r>
              <a:rPr lang="en-US" b="1" dirty="0" err="1"/>
              <a:t>cGvHD</a:t>
            </a:r>
            <a:r>
              <a:rPr lang="en-US" b="1" dirty="0"/>
              <a:t> representative </a:t>
            </a:r>
            <a:r>
              <a:rPr lang="en-GB" b="1" dirty="0"/>
              <a:t>patient. </a:t>
            </a:r>
            <a:r>
              <a:rPr lang="en-GB" dirty="0"/>
              <a:t>Gated live CD19+ B cells, excluding doublets, are first plotted against CD21/CD27. Then, CD21-/CD27- are further subdivided into CD10+CD21-CD27- immature/transitional B cells and CD10-CD21-CD27- exhausted B cells. 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945851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350D933D1F0B94BBAB0BD440E363FC8" ma:contentTypeVersion="7" ma:contentTypeDescription="Create a new document." ma:contentTypeScope="" ma:versionID="9b91d12c69b0b06fb5fc5553a5ae3899">
  <xsd:schema xmlns:xsd="http://www.w3.org/2001/XMLSchema" xmlns:p="http://schemas.microsoft.com/office/2006/metadata/properties" xmlns:ns2="d3c69c58-74ff-44a8-9788-42871589f19e" targetNamespace="http://schemas.microsoft.com/office/2006/metadata/properties" ma:root="true" ma:fieldsID="019318177470c37874020093bc95e111" ns2:_="">
    <xsd:import namespace="d3c69c58-74ff-44a8-9788-42871589f19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d3c69c58-74ff-44a8-9788-42871589f19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p:properties xmlns:p="http://schemas.microsoft.com/office/2006/metadata/properties" xmlns:xsi="http://www.w3.org/2001/XMLSchema-instance">
  <documentManagement>
    <StageName xmlns="d3c69c58-74ff-44a8-9788-42871589f19e" xsi:nil="true"/>
    <DocumentId xmlns="d3c69c58-74ff-44a8-9788-42871589f19e">Presentation 1.PPTX</DocumentId>
    <DocumentType xmlns="d3c69c58-74ff-44a8-9788-42871589f19e">Presentation</DocumentType>
    <FileFormat xmlns="d3c69c58-74ff-44a8-9788-42871589f19e">PPTX</FileFormat>
    <Checked_x0020_Out_x0020_To xmlns="d3c69c58-74ff-44a8-9788-42871589f19e">
      <UserInfo>
        <DisplayName/>
        <AccountId xsi:nil="true"/>
        <AccountType/>
      </UserInfo>
    </Checked_x0020_Out_x0020_To>
    <TitleName xmlns="d3c69c58-74ff-44a8-9788-42871589f19e">Presentation 1.PPTX</TitleName>
    <IsDeleted xmlns="d3c69c58-74ff-44a8-9788-42871589f19e">false</IsDeleted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1638290A-CE79-4435-A3DA-87491B638AF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3c69c58-74ff-44a8-9788-42871589f19e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2.xml><?xml version="1.0" encoding="utf-8"?>
<ds:datastoreItem xmlns:ds="http://schemas.openxmlformats.org/officeDocument/2006/customXml" ds:itemID="{DB6DFE66-509F-43D6-98C9-A2D2D44634E8}">
  <ds:schemaRefs>
    <ds:schemaRef ds:uri="http://schemas.microsoft.com/office/2006/metadata/properties"/>
    <ds:schemaRef ds:uri="d3c69c58-74ff-44a8-9788-42871589f19e"/>
  </ds:schemaRefs>
</ds:datastoreItem>
</file>

<file path=customXml/itemProps3.xml><?xml version="1.0" encoding="utf-8"?>
<ds:datastoreItem xmlns:ds="http://schemas.openxmlformats.org/officeDocument/2006/customXml" ds:itemID="{4F97AF9D-875A-4CE1-A7AD-111894E2618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</Words>
  <Application>Microsoft Office PowerPoint</Application>
  <PresentationFormat>Widescreen</PresentationFormat>
  <Paragraphs>3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hmad Khoder</dc:creator>
  <cp:lastModifiedBy>Elsa Carron</cp:lastModifiedBy>
  <cp:revision>2</cp:revision>
  <dcterms:created xsi:type="dcterms:W3CDTF">2017-10-17T23:17:38Z</dcterms:created>
  <dcterms:modified xsi:type="dcterms:W3CDTF">2018-01-04T11:22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350D933D1F0B94BBAB0BD440E363FC8</vt:lpwstr>
  </property>
</Properties>
</file>